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30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820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42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793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95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659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317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69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14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506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865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48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20062-D42B-4950-8CD2-5687B000BBB1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104A0-B56E-4E33-8AE9-D760A8A05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876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3.wdp"/><Relationship Id="rId5" Type="http://schemas.microsoft.com/office/2007/relationships/hdphoto" Target="../media/hdphoto2.wdp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9" name="Group 278"/>
          <p:cNvGrpSpPr/>
          <p:nvPr/>
        </p:nvGrpSpPr>
        <p:grpSpPr>
          <a:xfrm>
            <a:off x="20786" y="262221"/>
            <a:ext cx="3154334" cy="2785445"/>
            <a:chOff x="20786" y="262221"/>
            <a:chExt cx="3154334" cy="2785445"/>
          </a:xfrm>
        </p:grpSpPr>
        <p:pic>
          <p:nvPicPr>
            <p:cNvPr id="122" name="Picture 12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41" t="4010" r="44516" b="77315"/>
            <a:stretch/>
          </p:blipFill>
          <p:spPr>
            <a:xfrm>
              <a:off x="89020" y="609266"/>
              <a:ext cx="3086100" cy="24384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sp>
          <p:nvSpPr>
            <p:cNvPr id="126" name="TextBox 125"/>
            <p:cNvSpPr txBox="1"/>
            <p:nvPr/>
          </p:nvSpPr>
          <p:spPr>
            <a:xfrm>
              <a:off x="20786" y="262221"/>
              <a:ext cx="6174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NFk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Rectangle 276"/>
            <p:cNvSpPr/>
            <p:nvPr/>
          </p:nvSpPr>
          <p:spPr>
            <a:xfrm>
              <a:off x="638263" y="1794218"/>
              <a:ext cx="1302546" cy="31575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0" name="Group 289"/>
          <p:cNvGrpSpPr/>
          <p:nvPr/>
        </p:nvGrpSpPr>
        <p:grpSpPr>
          <a:xfrm>
            <a:off x="680615" y="1563716"/>
            <a:ext cx="1086506" cy="248922"/>
            <a:chOff x="680615" y="1563716"/>
            <a:chExt cx="1086506" cy="248922"/>
          </a:xfrm>
        </p:grpSpPr>
        <p:sp>
          <p:nvSpPr>
            <p:cNvPr id="286" name="TextBox 285"/>
            <p:cNvSpPr txBox="1"/>
            <p:nvPr/>
          </p:nvSpPr>
          <p:spPr>
            <a:xfrm>
              <a:off x="680615" y="1563716"/>
              <a:ext cx="199080" cy="24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87" name="TextBox 286"/>
            <p:cNvSpPr txBox="1"/>
            <p:nvPr/>
          </p:nvSpPr>
          <p:spPr>
            <a:xfrm>
              <a:off x="998516" y="1563716"/>
              <a:ext cx="199080" cy="24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1304725" y="1563716"/>
              <a:ext cx="199080" cy="24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89" name="TextBox 288"/>
            <p:cNvSpPr txBox="1"/>
            <p:nvPr/>
          </p:nvSpPr>
          <p:spPr>
            <a:xfrm>
              <a:off x="1568041" y="1563716"/>
              <a:ext cx="199080" cy="24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5327E65-8718-142F-12C5-94D646A5E883}"/>
              </a:ext>
            </a:extLst>
          </p:cNvPr>
          <p:cNvSpPr txBox="1"/>
          <p:nvPr/>
        </p:nvSpPr>
        <p:spPr>
          <a:xfrm>
            <a:off x="-10956" y="8931"/>
            <a:ext cx="3240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4-figure supplement 1 uncropped gel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7C9DF48A-133B-CA93-79A6-2F439CD7EF7F}"/>
              </a:ext>
            </a:extLst>
          </p:cNvPr>
          <p:cNvGrpSpPr/>
          <p:nvPr/>
        </p:nvGrpSpPr>
        <p:grpSpPr>
          <a:xfrm>
            <a:off x="3429000" y="372487"/>
            <a:ext cx="2895600" cy="1362689"/>
            <a:chOff x="112208" y="3081648"/>
            <a:chExt cx="2895600" cy="1362689"/>
          </a:xfrm>
        </p:grpSpPr>
        <p:sp>
          <p:nvSpPr>
            <p:cNvPr id="127" name="TextBox 126"/>
            <p:cNvSpPr txBox="1"/>
            <p:nvPr/>
          </p:nvSpPr>
          <p:spPr>
            <a:xfrm>
              <a:off x="165602" y="3081648"/>
              <a:ext cx="5389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FkB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3" name="Picture 11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71" t="12692" r="70166" b="65274"/>
            <a:stretch/>
          </p:blipFill>
          <p:spPr>
            <a:xfrm rot="5400000">
              <a:off x="1012319" y="2448848"/>
              <a:ext cx="1095378" cy="2895600"/>
            </a:xfrm>
            <a:prstGeom prst="rect">
              <a:avLst/>
            </a:prstGeom>
            <a:ln w="12700">
              <a:solidFill>
                <a:schemeClr val="dk1"/>
              </a:solidFill>
            </a:ln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26A64CB-CDCC-301A-CFC5-2375F5617F0D}"/>
                </a:ext>
              </a:extLst>
            </p:cNvPr>
            <p:cNvGrpSpPr/>
            <p:nvPr/>
          </p:nvGrpSpPr>
          <p:grpSpPr>
            <a:xfrm>
              <a:off x="653478" y="3513695"/>
              <a:ext cx="1086506" cy="248922"/>
              <a:chOff x="766275" y="1607239"/>
              <a:chExt cx="1086506" cy="248922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DD5A25C8-74E9-A9FD-51A3-B1BDDCF154FC}"/>
                  </a:ext>
                </a:extLst>
              </p:cNvPr>
              <p:cNvSpPr txBox="1"/>
              <p:nvPr/>
            </p:nvSpPr>
            <p:spPr>
              <a:xfrm>
                <a:off x="766275" y="1607239"/>
                <a:ext cx="199080" cy="2489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678A0FC-E68D-19AB-7C04-0A0488C4846B}"/>
                  </a:ext>
                </a:extLst>
              </p:cNvPr>
              <p:cNvSpPr txBox="1"/>
              <p:nvPr/>
            </p:nvSpPr>
            <p:spPr>
              <a:xfrm>
                <a:off x="1084176" y="1607239"/>
                <a:ext cx="199080" cy="2489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9BBC008-6162-3DD5-1F9C-482DF00C9655}"/>
                  </a:ext>
                </a:extLst>
              </p:cNvPr>
              <p:cNvSpPr txBox="1"/>
              <p:nvPr/>
            </p:nvSpPr>
            <p:spPr>
              <a:xfrm>
                <a:off x="1390385" y="1607239"/>
                <a:ext cx="199080" cy="2489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474CCCCF-C6BD-FFCC-519B-C8A20ED42F67}"/>
                  </a:ext>
                </a:extLst>
              </p:cNvPr>
              <p:cNvSpPr txBox="1"/>
              <p:nvPr/>
            </p:nvSpPr>
            <p:spPr>
              <a:xfrm>
                <a:off x="1653701" y="1607239"/>
                <a:ext cx="199080" cy="2489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6F0DD2B6-CC33-61F2-AD45-A961DB299633}"/>
                </a:ext>
              </a:extLst>
            </p:cNvPr>
            <p:cNvSpPr/>
            <p:nvPr/>
          </p:nvSpPr>
          <p:spPr>
            <a:xfrm>
              <a:off x="523438" y="3744616"/>
              <a:ext cx="1302546" cy="315757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8C7AB6C8-DA3A-1D97-4F01-FC07F7C5C4D8}"/>
              </a:ext>
            </a:extLst>
          </p:cNvPr>
          <p:cNvGrpSpPr/>
          <p:nvPr/>
        </p:nvGrpSpPr>
        <p:grpSpPr>
          <a:xfrm>
            <a:off x="116542" y="3133101"/>
            <a:ext cx="2899980" cy="2326808"/>
            <a:chOff x="62425" y="4620851"/>
            <a:chExt cx="2899980" cy="2326808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0D778C7-E81B-D47C-2D81-E036080C67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11" t="17688" r="47834" b="51111"/>
            <a:stretch/>
          </p:blipFill>
          <p:spPr>
            <a:xfrm rot="5400000">
              <a:off x="530355" y="4515609"/>
              <a:ext cx="1993900" cy="28702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1682B89-310C-F362-F6DD-C850ECFA40F1}"/>
                </a:ext>
              </a:extLst>
            </p:cNvPr>
            <p:cNvSpPr txBox="1"/>
            <p:nvPr/>
          </p:nvSpPr>
          <p:spPr>
            <a:xfrm>
              <a:off x="62425" y="4620851"/>
              <a:ext cx="99097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-Smad1/5/9</a:t>
              </a: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FDA492F3-FCC1-6845-6323-4E7FC1F9596A}"/>
                </a:ext>
              </a:extLst>
            </p:cNvPr>
            <p:cNvGrpSpPr/>
            <p:nvPr/>
          </p:nvGrpSpPr>
          <p:grpSpPr>
            <a:xfrm>
              <a:off x="427058" y="5131321"/>
              <a:ext cx="1269169" cy="552236"/>
              <a:chOff x="3774815" y="5524169"/>
              <a:chExt cx="1269169" cy="552236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3E2090B-74E4-5969-62D6-1840ABC5083E}"/>
                  </a:ext>
                </a:extLst>
              </p:cNvPr>
              <p:cNvGrpSpPr/>
              <p:nvPr/>
            </p:nvGrpSpPr>
            <p:grpSpPr>
              <a:xfrm>
                <a:off x="3884178" y="5524169"/>
                <a:ext cx="1086506" cy="248922"/>
                <a:chOff x="745598" y="1601681"/>
                <a:chExt cx="1086506" cy="248922"/>
              </a:xfrm>
            </p:grpSpPr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9217BF3-1DCD-0853-694C-4C1B282AA56F}"/>
                    </a:ext>
                  </a:extLst>
                </p:cNvPr>
                <p:cNvSpPr txBox="1"/>
                <p:nvPr/>
              </p:nvSpPr>
              <p:spPr>
                <a:xfrm>
                  <a:off x="745598" y="1601681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BEC31814-83FA-86C8-53EC-EAF76F4E47CB}"/>
                    </a:ext>
                  </a:extLst>
                </p:cNvPr>
                <p:cNvSpPr txBox="1"/>
                <p:nvPr/>
              </p:nvSpPr>
              <p:spPr>
                <a:xfrm>
                  <a:off x="1063499" y="1601681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13DF538A-6EDE-A295-A736-322D7E3AE0DC}"/>
                    </a:ext>
                  </a:extLst>
                </p:cNvPr>
                <p:cNvSpPr txBox="1"/>
                <p:nvPr/>
              </p:nvSpPr>
              <p:spPr>
                <a:xfrm>
                  <a:off x="1369708" y="1601681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88B01F5E-132C-02FA-0CB8-8869FF745079}"/>
                    </a:ext>
                  </a:extLst>
                </p:cNvPr>
                <p:cNvSpPr txBox="1"/>
                <p:nvPr/>
              </p:nvSpPr>
              <p:spPr>
                <a:xfrm>
                  <a:off x="1633024" y="1601681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B3B17988-4846-2D27-F7C2-799080C1B46F}"/>
                  </a:ext>
                </a:extLst>
              </p:cNvPr>
              <p:cNvSpPr/>
              <p:nvPr/>
            </p:nvSpPr>
            <p:spPr>
              <a:xfrm>
                <a:off x="3774815" y="5760648"/>
                <a:ext cx="1269169" cy="315757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1A87FE4C-0CC1-A248-BEA2-B17E815F3934}"/>
              </a:ext>
            </a:extLst>
          </p:cNvPr>
          <p:cNvGrpSpPr/>
          <p:nvPr/>
        </p:nvGrpSpPr>
        <p:grpSpPr>
          <a:xfrm>
            <a:off x="2106831" y="7799205"/>
            <a:ext cx="3050252" cy="763499"/>
            <a:chOff x="3386316" y="1089711"/>
            <a:chExt cx="3050252" cy="763499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6B1F283-B39B-501C-EFE4-6350225A28E0}"/>
                </a:ext>
              </a:extLst>
            </p:cNvPr>
            <p:cNvSpPr txBox="1"/>
            <p:nvPr/>
          </p:nvSpPr>
          <p:spPr>
            <a:xfrm>
              <a:off x="3386316" y="1255572"/>
              <a:ext cx="16608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e 2 - BMP4 10 ng/ml 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563621A-1ABC-0C08-4B15-6B817D1E9D01}"/>
                </a:ext>
              </a:extLst>
            </p:cNvPr>
            <p:cNvSpPr txBox="1"/>
            <p:nvPr/>
          </p:nvSpPr>
          <p:spPr>
            <a:xfrm>
              <a:off x="3386316" y="1591600"/>
              <a:ext cx="30502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e 4 - PAM3CSK4 10µg/ml+ BMP4 10 ng/ml 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1278C1E-43E5-D1DA-D73A-75A3CEDE099B}"/>
                </a:ext>
              </a:extLst>
            </p:cNvPr>
            <p:cNvSpPr txBox="1"/>
            <p:nvPr/>
          </p:nvSpPr>
          <p:spPr>
            <a:xfrm>
              <a:off x="3386316" y="1432086"/>
              <a:ext cx="20891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e 3 - PAM3CSK4 10µg/ml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1C1C893-FB9E-9BF3-504F-A101E2B9B87C}"/>
                </a:ext>
              </a:extLst>
            </p:cNvPr>
            <p:cNvSpPr txBox="1"/>
            <p:nvPr/>
          </p:nvSpPr>
          <p:spPr>
            <a:xfrm>
              <a:off x="3386316" y="1089711"/>
              <a:ext cx="128196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Line 1 - control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D04AC36A-D51D-14C5-72F3-AD1394AC20C0}"/>
              </a:ext>
            </a:extLst>
          </p:cNvPr>
          <p:cNvGrpSpPr/>
          <p:nvPr/>
        </p:nvGrpSpPr>
        <p:grpSpPr>
          <a:xfrm>
            <a:off x="3229992" y="3427058"/>
            <a:ext cx="2927856" cy="1573437"/>
            <a:chOff x="20786" y="7018327"/>
            <a:chExt cx="2927856" cy="1573437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4B273C70-9168-39DA-4BB8-BA9E1465F5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56" t="60973" r="59935" b="8179"/>
            <a:stretch/>
          </p:blipFill>
          <p:spPr>
            <a:xfrm rot="5400000">
              <a:off x="897593" y="6540715"/>
              <a:ext cx="1269998" cy="28321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D0A68FD7-94D1-17CC-0A58-AB29B53DF1E7}"/>
                </a:ext>
              </a:extLst>
            </p:cNvPr>
            <p:cNvSpPr txBox="1"/>
            <p:nvPr/>
          </p:nvSpPr>
          <p:spPr>
            <a:xfrm>
              <a:off x="20786" y="7018327"/>
              <a:ext cx="7104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SMAD1 </a:t>
              </a:r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AC99E65F-5F8C-6392-D07A-F045422DD184}"/>
                </a:ext>
              </a:extLst>
            </p:cNvPr>
            <p:cNvGrpSpPr/>
            <p:nvPr/>
          </p:nvGrpSpPr>
          <p:grpSpPr>
            <a:xfrm>
              <a:off x="422751" y="7316446"/>
              <a:ext cx="1302546" cy="559358"/>
              <a:chOff x="3774815" y="5517047"/>
              <a:chExt cx="1302546" cy="559358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C3497792-465E-FE10-76D3-10949505DDDA}"/>
                  </a:ext>
                </a:extLst>
              </p:cNvPr>
              <p:cNvGrpSpPr/>
              <p:nvPr/>
            </p:nvGrpSpPr>
            <p:grpSpPr>
              <a:xfrm>
                <a:off x="3808774" y="5517047"/>
                <a:ext cx="1086506" cy="248922"/>
                <a:chOff x="670194" y="1594559"/>
                <a:chExt cx="1086506" cy="248922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087EA86A-98B4-D528-825B-AA2FCFD9BEC5}"/>
                    </a:ext>
                  </a:extLst>
                </p:cNvPr>
                <p:cNvSpPr txBox="1"/>
                <p:nvPr/>
              </p:nvSpPr>
              <p:spPr>
                <a:xfrm>
                  <a:off x="670194" y="1594559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C1AE9715-B9F2-364B-D6DE-C1385F9B7517}"/>
                    </a:ext>
                  </a:extLst>
                </p:cNvPr>
                <p:cNvSpPr txBox="1"/>
                <p:nvPr/>
              </p:nvSpPr>
              <p:spPr>
                <a:xfrm>
                  <a:off x="988095" y="1594559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8C7B9A19-EF98-2CA9-1054-2C74387682C0}"/>
                    </a:ext>
                  </a:extLst>
                </p:cNvPr>
                <p:cNvSpPr txBox="1"/>
                <p:nvPr/>
              </p:nvSpPr>
              <p:spPr>
                <a:xfrm>
                  <a:off x="1294304" y="1594559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D676FEE9-216F-146A-DCAD-69AB5339F6F1}"/>
                    </a:ext>
                  </a:extLst>
                </p:cNvPr>
                <p:cNvSpPr txBox="1"/>
                <p:nvPr/>
              </p:nvSpPr>
              <p:spPr>
                <a:xfrm>
                  <a:off x="1557620" y="1594559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AAD40344-669B-D616-23F8-B15B3B0E498D}"/>
                  </a:ext>
                </a:extLst>
              </p:cNvPr>
              <p:cNvSpPr/>
              <p:nvPr/>
            </p:nvSpPr>
            <p:spPr>
              <a:xfrm>
                <a:off x="3774815" y="5760648"/>
                <a:ext cx="1302546" cy="315757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FB2F0279-E723-E995-1607-53A99C803CBA}"/>
              </a:ext>
            </a:extLst>
          </p:cNvPr>
          <p:cNvGrpSpPr/>
          <p:nvPr/>
        </p:nvGrpSpPr>
        <p:grpSpPr>
          <a:xfrm>
            <a:off x="46346" y="5637471"/>
            <a:ext cx="2914918" cy="1705004"/>
            <a:chOff x="0" y="0"/>
            <a:chExt cx="2914918" cy="1705004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4B50DBD0-F64F-C5CF-29EA-052634D613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263" t="64754" r="59589" b="5086"/>
            <a:stretch/>
          </p:blipFill>
          <p:spPr>
            <a:xfrm rot="5400000">
              <a:off x="854470" y="-355445"/>
              <a:ext cx="1341118" cy="27797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FB0CE306-CA26-7BDC-312D-237A1FC72BE1}"/>
                    </a:ext>
                  </a:extLst>
                </p:cNvPr>
                <p:cNvSpPr txBox="1"/>
                <p:nvPr/>
              </p:nvSpPr>
              <p:spPr>
                <a:xfrm>
                  <a:off x="0" y="0"/>
                  <a:ext cx="47000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kB</a:t>
                  </a:r>
                  <a14:m>
                    <m:oMath xmlns:m="http://schemas.openxmlformats.org/officeDocument/2006/math">
                      <m:r>
                        <m:rPr>
                          <m:sty m:val="p"/>
                        </m:rPr>
                        <a:rPr lang="el-GR" sz="1100" i="1" smtClean="0">
                          <a:latin typeface="Cambria Math" panose="02040503050406030204" pitchFamily="18" charset="0"/>
                          <a:cs typeface="Arial" panose="020B0604020202020204" pitchFamily="34" charset="0"/>
                        </a:rPr>
                        <m:t>ά</m:t>
                      </m:r>
                    </m:oMath>
                  </a14:m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FB0CE306-CA26-7BDC-312D-237A1FC72BE1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0" y="0"/>
                  <a:ext cx="470000" cy="261610"/>
                </a:xfrm>
                <a:prstGeom prst="rect">
                  <a:avLst/>
                </a:prstGeom>
                <a:blipFill>
                  <a:blip r:embed="rId9"/>
                  <a:stretch>
                    <a:fillRect t="-2326" b="-1395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5D811171-BC84-FDB0-2228-A33F72D2F04B}"/>
                </a:ext>
              </a:extLst>
            </p:cNvPr>
            <p:cNvGrpSpPr/>
            <p:nvPr/>
          </p:nvGrpSpPr>
          <p:grpSpPr>
            <a:xfrm>
              <a:off x="415670" y="728001"/>
              <a:ext cx="1302546" cy="590201"/>
              <a:chOff x="3774815" y="5486204"/>
              <a:chExt cx="1302546" cy="590201"/>
            </a:xfrm>
          </p:grpSpPr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EC011B5B-3440-7056-4E44-489A6FBCB3D4}"/>
                  </a:ext>
                </a:extLst>
              </p:cNvPr>
              <p:cNvGrpSpPr/>
              <p:nvPr/>
            </p:nvGrpSpPr>
            <p:grpSpPr>
              <a:xfrm>
                <a:off x="3819195" y="5486204"/>
                <a:ext cx="1086506" cy="248922"/>
                <a:chOff x="680615" y="1563716"/>
                <a:chExt cx="1086506" cy="248922"/>
              </a:xfrm>
            </p:grpSpPr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A8077095-1E38-4254-638D-69EFE85E97E9}"/>
                    </a:ext>
                  </a:extLst>
                </p:cNvPr>
                <p:cNvSpPr txBox="1"/>
                <p:nvPr/>
              </p:nvSpPr>
              <p:spPr>
                <a:xfrm>
                  <a:off x="680615" y="1563716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224D8A6F-28F8-6938-77F0-6AA2A12618BD}"/>
                    </a:ext>
                  </a:extLst>
                </p:cNvPr>
                <p:cNvSpPr txBox="1"/>
                <p:nvPr/>
              </p:nvSpPr>
              <p:spPr>
                <a:xfrm>
                  <a:off x="998516" y="1563716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E965DB54-C87C-1FB0-8C58-153B7C076F71}"/>
                    </a:ext>
                  </a:extLst>
                </p:cNvPr>
                <p:cNvSpPr txBox="1"/>
                <p:nvPr/>
              </p:nvSpPr>
              <p:spPr>
                <a:xfrm>
                  <a:off x="1304725" y="1563716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74D25EE6-87B1-B8EA-D8AB-DF432AB75F55}"/>
                    </a:ext>
                  </a:extLst>
                </p:cNvPr>
                <p:cNvSpPr txBox="1"/>
                <p:nvPr/>
              </p:nvSpPr>
              <p:spPr>
                <a:xfrm>
                  <a:off x="1568041" y="1563716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EAE9C21D-E829-02F2-F6A6-7978CB5BF8DF}"/>
                  </a:ext>
                </a:extLst>
              </p:cNvPr>
              <p:cNvSpPr/>
              <p:nvPr/>
            </p:nvSpPr>
            <p:spPr>
              <a:xfrm>
                <a:off x="3774815" y="5760648"/>
                <a:ext cx="1302546" cy="315757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A9BDE75C-B381-6B0D-6E6D-B890AE91B2B0}"/>
              </a:ext>
            </a:extLst>
          </p:cNvPr>
          <p:cNvGrpSpPr/>
          <p:nvPr/>
        </p:nvGrpSpPr>
        <p:grpSpPr>
          <a:xfrm>
            <a:off x="3175120" y="5803507"/>
            <a:ext cx="2983808" cy="1490338"/>
            <a:chOff x="0" y="3568197"/>
            <a:chExt cx="2983808" cy="1490338"/>
          </a:xfrm>
        </p:grpSpPr>
        <p:pic>
          <p:nvPicPr>
            <p:cNvPr id="57" name="Picture 56">
              <a:extLst>
                <a:ext uri="{FF2B5EF4-FFF2-40B4-BE49-F238E27FC236}">
                  <a16:creationId xmlns:a16="http://schemas.microsoft.com/office/drawing/2014/main" id="{D5189852-4295-9A4A-B17B-902341CA9C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10" t="13111" r="63409" b="55338"/>
            <a:stretch/>
          </p:blipFill>
          <p:spPr>
            <a:xfrm rot="5400000">
              <a:off x="916882" y="2991609"/>
              <a:ext cx="1228728" cy="2905124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3073144-0BBA-6326-E2AA-472C760EDFF5}"/>
                </a:ext>
              </a:extLst>
            </p:cNvPr>
            <p:cNvSpPr txBox="1"/>
            <p:nvPr/>
          </p:nvSpPr>
          <p:spPr>
            <a:xfrm>
              <a:off x="0" y="3568197"/>
              <a:ext cx="6880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grpSp>
          <p:nvGrpSpPr>
            <p:cNvPr id="59" name="Group 58">
              <a:extLst>
                <a:ext uri="{FF2B5EF4-FFF2-40B4-BE49-F238E27FC236}">
                  <a16:creationId xmlns:a16="http://schemas.microsoft.com/office/drawing/2014/main" id="{D169FD5C-FE22-C58E-D336-5D1DAF4B380C}"/>
                </a:ext>
              </a:extLst>
            </p:cNvPr>
            <p:cNvGrpSpPr/>
            <p:nvPr/>
          </p:nvGrpSpPr>
          <p:grpSpPr>
            <a:xfrm>
              <a:off x="470014" y="4298023"/>
              <a:ext cx="1248202" cy="549722"/>
              <a:chOff x="3790705" y="5527922"/>
              <a:chExt cx="1248202" cy="549722"/>
            </a:xfrm>
          </p:grpSpPr>
          <p:grpSp>
            <p:nvGrpSpPr>
              <p:cNvPr id="60" name="Group 59">
                <a:extLst>
                  <a:ext uri="{FF2B5EF4-FFF2-40B4-BE49-F238E27FC236}">
                    <a16:creationId xmlns:a16="http://schemas.microsoft.com/office/drawing/2014/main" id="{99788D63-2200-CF0E-0ADC-55E8064F83E1}"/>
                  </a:ext>
                </a:extLst>
              </p:cNvPr>
              <p:cNvGrpSpPr/>
              <p:nvPr/>
            </p:nvGrpSpPr>
            <p:grpSpPr>
              <a:xfrm>
                <a:off x="3790705" y="5527922"/>
                <a:ext cx="1086506" cy="248922"/>
                <a:chOff x="652125" y="1605434"/>
                <a:chExt cx="1086506" cy="248922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67D12616-F628-5923-9353-5FD8D1B9C0EB}"/>
                    </a:ext>
                  </a:extLst>
                </p:cNvPr>
                <p:cNvSpPr txBox="1"/>
                <p:nvPr/>
              </p:nvSpPr>
              <p:spPr>
                <a:xfrm>
                  <a:off x="652125" y="1605434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5C2A2FC2-F265-EC47-52A5-DDB987D5B682}"/>
                    </a:ext>
                  </a:extLst>
                </p:cNvPr>
                <p:cNvSpPr txBox="1"/>
                <p:nvPr/>
              </p:nvSpPr>
              <p:spPr>
                <a:xfrm>
                  <a:off x="970026" y="1605434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04F8B097-FB65-F686-ED93-1358F01EFDC0}"/>
                    </a:ext>
                  </a:extLst>
                </p:cNvPr>
                <p:cNvSpPr txBox="1"/>
                <p:nvPr/>
              </p:nvSpPr>
              <p:spPr>
                <a:xfrm>
                  <a:off x="1276235" y="1605434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D6271FD3-B1DF-999B-8FB3-7DA66E81E375}"/>
                    </a:ext>
                  </a:extLst>
                </p:cNvPr>
                <p:cNvSpPr txBox="1"/>
                <p:nvPr/>
              </p:nvSpPr>
              <p:spPr>
                <a:xfrm>
                  <a:off x="1539551" y="1605434"/>
                  <a:ext cx="199080" cy="248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</a:p>
              </p:txBody>
            </p:sp>
          </p:grp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B0A2F537-15DF-CF51-5569-8CF83E083399}"/>
                  </a:ext>
                </a:extLst>
              </p:cNvPr>
              <p:cNvSpPr/>
              <p:nvPr/>
            </p:nvSpPr>
            <p:spPr>
              <a:xfrm>
                <a:off x="3819195" y="5761887"/>
                <a:ext cx="1219712" cy="315757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710919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69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>Cleveland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evlakova, Irina</dc:creator>
  <cp:lastModifiedBy>Zhevlakova, Irina</cp:lastModifiedBy>
  <cp:revision>15</cp:revision>
  <dcterms:created xsi:type="dcterms:W3CDTF">2022-12-05T20:54:19Z</dcterms:created>
  <dcterms:modified xsi:type="dcterms:W3CDTF">2024-01-25T19:54:43Z</dcterms:modified>
</cp:coreProperties>
</file>